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6201" autoAdjust="0"/>
  </p:normalViewPr>
  <p:slideViewPr>
    <p:cSldViewPr snapToGrid="0">
      <p:cViewPr varScale="1">
        <p:scale>
          <a:sx n="80" d="100"/>
          <a:sy n="80" d="100"/>
        </p:scale>
        <p:origin x="134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415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1662"/>
            </a:lvl1pPr>
            <a:lvl2pPr marL="316520" indent="0" algn="ctr">
              <a:buNone/>
              <a:defRPr sz="1385"/>
            </a:lvl2pPr>
            <a:lvl3pPr marL="633039" indent="0" algn="ctr">
              <a:buNone/>
              <a:defRPr sz="1246"/>
            </a:lvl3pPr>
            <a:lvl4pPr marL="949559" indent="0" algn="ctr">
              <a:buNone/>
              <a:defRPr sz="1108"/>
            </a:lvl4pPr>
            <a:lvl5pPr marL="1266078" indent="0" algn="ctr">
              <a:buNone/>
              <a:defRPr sz="1108"/>
            </a:lvl5pPr>
            <a:lvl6pPr marL="1582598" indent="0" algn="ctr">
              <a:buNone/>
              <a:defRPr sz="1108"/>
            </a:lvl6pPr>
            <a:lvl7pPr marL="1899117" indent="0" algn="ctr">
              <a:buNone/>
              <a:defRPr sz="1108"/>
            </a:lvl7pPr>
            <a:lvl8pPr marL="2215637" indent="0" algn="ctr">
              <a:buNone/>
              <a:defRPr sz="1108"/>
            </a:lvl8pPr>
            <a:lvl9pPr marL="2532156" indent="0" algn="ctr">
              <a:buNone/>
              <a:defRPr sz="110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F3AC6-14BF-4024-9B02-77DEF94825F2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3A088-14F6-43FF-94CC-CF0A041B3E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2558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F3AC6-14BF-4024-9B02-77DEF94825F2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3A088-14F6-43FF-94CC-CF0A041B3E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85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F3AC6-14BF-4024-9B02-77DEF94825F2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3A088-14F6-43FF-94CC-CF0A041B3E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34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F3AC6-14BF-4024-9B02-77DEF94825F2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3A088-14F6-43FF-94CC-CF0A041B3E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80694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81" y="1709740"/>
            <a:ext cx="8543925" cy="2852737"/>
          </a:xfrm>
        </p:spPr>
        <p:txBody>
          <a:bodyPr anchor="b"/>
          <a:lstStyle>
            <a:lvl1pPr>
              <a:defRPr sz="415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81" y="4589466"/>
            <a:ext cx="8543925" cy="1500187"/>
          </a:xfrm>
        </p:spPr>
        <p:txBody>
          <a:bodyPr/>
          <a:lstStyle>
            <a:lvl1pPr marL="0" indent="0">
              <a:buNone/>
              <a:defRPr sz="1662">
                <a:solidFill>
                  <a:schemeClr val="tx1"/>
                </a:solidFill>
              </a:defRPr>
            </a:lvl1pPr>
            <a:lvl2pPr marL="316520" indent="0">
              <a:buNone/>
              <a:defRPr sz="1385">
                <a:solidFill>
                  <a:schemeClr val="tx1">
                    <a:tint val="75000"/>
                  </a:schemeClr>
                </a:solidFill>
              </a:defRPr>
            </a:lvl2pPr>
            <a:lvl3pPr marL="633039" indent="0">
              <a:buNone/>
              <a:defRPr sz="1246">
                <a:solidFill>
                  <a:schemeClr val="tx1">
                    <a:tint val="75000"/>
                  </a:schemeClr>
                </a:solidFill>
              </a:defRPr>
            </a:lvl3pPr>
            <a:lvl4pPr marL="949559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4pPr>
            <a:lvl5pPr marL="1266078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5pPr>
            <a:lvl6pPr marL="1582598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6pPr>
            <a:lvl7pPr marL="1899117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7pPr>
            <a:lvl8pPr marL="2215637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8pPr>
            <a:lvl9pPr marL="2532156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F3AC6-14BF-4024-9B02-77DEF94825F2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3A088-14F6-43FF-94CC-CF0A041B3E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3722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F3AC6-14BF-4024-9B02-77DEF94825F2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3A088-14F6-43FF-94CC-CF0A041B3E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2058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30" y="1681164"/>
            <a:ext cx="4190702" cy="823912"/>
          </a:xfrm>
        </p:spPr>
        <p:txBody>
          <a:bodyPr anchor="b"/>
          <a:lstStyle>
            <a:lvl1pPr marL="0" indent="0">
              <a:buNone/>
              <a:defRPr sz="1662" b="1"/>
            </a:lvl1pPr>
            <a:lvl2pPr marL="316520" indent="0">
              <a:buNone/>
              <a:defRPr sz="1385" b="1"/>
            </a:lvl2pPr>
            <a:lvl3pPr marL="633039" indent="0">
              <a:buNone/>
              <a:defRPr sz="1246" b="1"/>
            </a:lvl3pPr>
            <a:lvl4pPr marL="949559" indent="0">
              <a:buNone/>
              <a:defRPr sz="1108" b="1"/>
            </a:lvl4pPr>
            <a:lvl5pPr marL="1266078" indent="0">
              <a:buNone/>
              <a:defRPr sz="1108" b="1"/>
            </a:lvl5pPr>
            <a:lvl6pPr marL="1582598" indent="0">
              <a:buNone/>
              <a:defRPr sz="1108" b="1"/>
            </a:lvl6pPr>
            <a:lvl7pPr marL="1899117" indent="0">
              <a:buNone/>
              <a:defRPr sz="1108" b="1"/>
            </a:lvl7pPr>
            <a:lvl8pPr marL="2215637" indent="0">
              <a:buNone/>
              <a:defRPr sz="1108" b="1"/>
            </a:lvl8pPr>
            <a:lvl9pPr marL="2532156" indent="0">
              <a:buNone/>
              <a:defRPr sz="110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30" y="2505076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4" y="1681164"/>
            <a:ext cx="4211340" cy="823912"/>
          </a:xfrm>
        </p:spPr>
        <p:txBody>
          <a:bodyPr anchor="b"/>
          <a:lstStyle>
            <a:lvl1pPr marL="0" indent="0">
              <a:buNone/>
              <a:defRPr sz="1662" b="1"/>
            </a:lvl1pPr>
            <a:lvl2pPr marL="316520" indent="0">
              <a:buNone/>
              <a:defRPr sz="1385" b="1"/>
            </a:lvl2pPr>
            <a:lvl3pPr marL="633039" indent="0">
              <a:buNone/>
              <a:defRPr sz="1246" b="1"/>
            </a:lvl3pPr>
            <a:lvl4pPr marL="949559" indent="0">
              <a:buNone/>
              <a:defRPr sz="1108" b="1"/>
            </a:lvl4pPr>
            <a:lvl5pPr marL="1266078" indent="0">
              <a:buNone/>
              <a:defRPr sz="1108" b="1"/>
            </a:lvl5pPr>
            <a:lvl6pPr marL="1582598" indent="0">
              <a:buNone/>
              <a:defRPr sz="1108" b="1"/>
            </a:lvl6pPr>
            <a:lvl7pPr marL="1899117" indent="0">
              <a:buNone/>
              <a:defRPr sz="1108" b="1"/>
            </a:lvl7pPr>
            <a:lvl8pPr marL="2215637" indent="0">
              <a:buNone/>
              <a:defRPr sz="1108" b="1"/>
            </a:lvl8pPr>
            <a:lvl9pPr marL="2532156" indent="0">
              <a:buNone/>
              <a:defRPr sz="110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4" y="2505076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F3AC6-14BF-4024-9B02-77DEF94825F2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3A088-14F6-43FF-94CC-CF0A041B3E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075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F3AC6-14BF-4024-9B02-77DEF94825F2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3A088-14F6-43FF-94CC-CF0A041B3E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4762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F3AC6-14BF-4024-9B02-77DEF94825F2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3A088-14F6-43FF-94CC-CF0A041B3E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29952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221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1" y="987428"/>
            <a:ext cx="5014913" cy="4873625"/>
          </a:xfrm>
        </p:spPr>
        <p:txBody>
          <a:bodyPr/>
          <a:lstStyle>
            <a:lvl1pPr>
              <a:defRPr sz="2215"/>
            </a:lvl1pPr>
            <a:lvl2pPr>
              <a:defRPr sz="1938"/>
            </a:lvl2pPr>
            <a:lvl3pPr>
              <a:defRPr sz="1662"/>
            </a:lvl3pPr>
            <a:lvl4pPr>
              <a:defRPr sz="1385"/>
            </a:lvl4pPr>
            <a:lvl5pPr>
              <a:defRPr sz="1385"/>
            </a:lvl5pPr>
            <a:lvl6pPr>
              <a:defRPr sz="1385"/>
            </a:lvl6pPr>
            <a:lvl7pPr>
              <a:defRPr sz="1385"/>
            </a:lvl7pPr>
            <a:lvl8pPr>
              <a:defRPr sz="1385"/>
            </a:lvl8pPr>
            <a:lvl9pPr>
              <a:defRPr sz="138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108"/>
            </a:lvl1pPr>
            <a:lvl2pPr marL="316520" indent="0">
              <a:buNone/>
              <a:defRPr sz="969"/>
            </a:lvl2pPr>
            <a:lvl3pPr marL="633039" indent="0">
              <a:buNone/>
              <a:defRPr sz="831"/>
            </a:lvl3pPr>
            <a:lvl4pPr marL="949559" indent="0">
              <a:buNone/>
              <a:defRPr sz="692"/>
            </a:lvl4pPr>
            <a:lvl5pPr marL="1266078" indent="0">
              <a:buNone/>
              <a:defRPr sz="692"/>
            </a:lvl5pPr>
            <a:lvl6pPr marL="1582598" indent="0">
              <a:buNone/>
              <a:defRPr sz="692"/>
            </a:lvl6pPr>
            <a:lvl7pPr marL="1899117" indent="0">
              <a:buNone/>
              <a:defRPr sz="692"/>
            </a:lvl7pPr>
            <a:lvl8pPr marL="2215637" indent="0">
              <a:buNone/>
              <a:defRPr sz="692"/>
            </a:lvl8pPr>
            <a:lvl9pPr marL="2532156" indent="0">
              <a:buNone/>
              <a:defRPr sz="69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F3AC6-14BF-4024-9B02-77DEF94825F2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3A088-14F6-43FF-94CC-CF0A041B3E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430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221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1" y="987428"/>
            <a:ext cx="5014913" cy="4873625"/>
          </a:xfrm>
        </p:spPr>
        <p:txBody>
          <a:bodyPr anchor="t"/>
          <a:lstStyle>
            <a:lvl1pPr marL="0" indent="0">
              <a:buNone/>
              <a:defRPr sz="2215"/>
            </a:lvl1pPr>
            <a:lvl2pPr marL="316520" indent="0">
              <a:buNone/>
              <a:defRPr sz="1938"/>
            </a:lvl2pPr>
            <a:lvl3pPr marL="633039" indent="0">
              <a:buNone/>
              <a:defRPr sz="1662"/>
            </a:lvl3pPr>
            <a:lvl4pPr marL="949559" indent="0">
              <a:buNone/>
              <a:defRPr sz="1385"/>
            </a:lvl4pPr>
            <a:lvl5pPr marL="1266078" indent="0">
              <a:buNone/>
              <a:defRPr sz="1385"/>
            </a:lvl5pPr>
            <a:lvl6pPr marL="1582598" indent="0">
              <a:buNone/>
              <a:defRPr sz="1385"/>
            </a:lvl6pPr>
            <a:lvl7pPr marL="1899117" indent="0">
              <a:buNone/>
              <a:defRPr sz="1385"/>
            </a:lvl7pPr>
            <a:lvl8pPr marL="2215637" indent="0">
              <a:buNone/>
              <a:defRPr sz="1385"/>
            </a:lvl8pPr>
            <a:lvl9pPr marL="2532156" indent="0">
              <a:buNone/>
              <a:defRPr sz="138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108"/>
            </a:lvl1pPr>
            <a:lvl2pPr marL="316520" indent="0">
              <a:buNone/>
              <a:defRPr sz="969"/>
            </a:lvl2pPr>
            <a:lvl3pPr marL="633039" indent="0">
              <a:buNone/>
              <a:defRPr sz="831"/>
            </a:lvl3pPr>
            <a:lvl4pPr marL="949559" indent="0">
              <a:buNone/>
              <a:defRPr sz="692"/>
            </a:lvl4pPr>
            <a:lvl5pPr marL="1266078" indent="0">
              <a:buNone/>
              <a:defRPr sz="692"/>
            </a:lvl5pPr>
            <a:lvl6pPr marL="1582598" indent="0">
              <a:buNone/>
              <a:defRPr sz="692"/>
            </a:lvl6pPr>
            <a:lvl7pPr marL="1899117" indent="0">
              <a:buNone/>
              <a:defRPr sz="692"/>
            </a:lvl7pPr>
            <a:lvl8pPr marL="2215637" indent="0">
              <a:buNone/>
              <a:defRPr sz="692"/>
            </a:lvl8pPr>
            <a:lvl9pPr marL="2532156" indent="0">
              <a:buNone/>
              <a:defRPr sz="69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F3AC6-14BF-4024-9B02-77DEF94825F2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3A088-14F6-43FF-94CC-CF0A041B3E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8012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9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CF3AC6-14BF-4024-9B02-77DEF94825F2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4" y="6356353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73A088-14F6-43FF-94CC-CF0A041B3E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1204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33039" rtl="0" eaLnBrk="1" latinLnBrk="0" hangingPunct="1">
        <a:lnSpc>
          <a:spcPct val="90000"/>
        </a:lnSpc>
        <a:spcBef>
          <a:spcPct val="0"/>
        </a:spcBef>
        <a:buNone/>
        <a:defRPr sz="304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8260" indent="-158260" algn="l" defTabSz="633039" rtl="0" eaLnBrk="1" latinLnBrk="0" hangingPunct="1">
        <a:lnSpc>
          <a:spcPct val="90000"/>
        </a:lnSpc>
        <a:spcBef>
          <a:spcPts val="692"/>
        </a:spcBef>
        <a:buFont typeface="Arial" panose="020B0604020202020204" pitchFamily="34" charset="0"/>
        <a:buChar char="•"/>
        <a:defRPr sz="1938" kern="1200">
          <a:solidFill>
            <a:schemeClr val="tx1"/>
          </a:solidFill>
          <a:latin typeface="+mn-lt"/>
          <a:ea typeface="+mn-ea"/>
          <a:cs typeface="+mn-cs"/>
        </a:defRPr>
      </a:lvl1pPr>
      <a:lvl2pPr marL="474779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662" kern="1200">
          <a:solidFill>
            <a:schemeClr val="tx1"/>
          </a:solidFill>
          <a:latin typeface="+mn-lt"/>
          <a:ea typeface="+mn-ea"/>
          <a:cs typeface="+mn-cs"/>
        </a:defRPr>
      </a:lvl2pPr>
      <a:lvl3pPr marL="791299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3pPr>
      <a:lvl4pPr marL="1107818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4pPr>
      <a:lvl5pPr marL="1424338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5pPr>
      <a:lvl6pPr marL="1740858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6pPr>
      <a:lvl7pPr marL="2057377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7pPr>
      <a:lvl8pPr marL="2373897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8pPr>
      <a:lvl9pPr marL="2690416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1pPr>
      <a:lvl2pPr marL="316520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2pPr>
      <a:lvl3pPr marL="633039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3pPr>
      <a:lvl4pPr marL="949559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4pPr>
      <a:lvl5pPr marL="1266078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5pPr>
      <a:lvl6pPr marL="1582598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6pPr>
      <a:lvl7pPr marL="1899117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7pPr>
      <a:lvl8pPr marL="2215637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8pPr>
      <a:lvl9pPr marL="2532156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Picture 81" descr="A diagram of a diagram&#10;&#10;Description automatically generated">
            <a:extLst>
              <a:ext uri="{FF2B5EF4-FFF2-40B4-BE49-F238E27FC236}">
                <a16:creationId xmlns:a16="http://schemas.microsoft.com/office/drawing/2014/main" id="{C81A7D7A-6826-AF73-B9AE-724BAF1BFDE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167"/>
          <a:stretch/>
        </p:blipFill>
        <p:spPr>
          <a:xfrm>
            <a:off x="5214525" y="0"/>
            <a:ext cx="4500000" cy="2385391"/>
          </a:xfrm>
          <a:prstGeom prst="rect">
            <a:avLst/>
          </a:prstGeom>
        </p:spPr>
      </p:pic>
      <p:pic>
        <p:nvPicPr>
          <p:cNvPr id="84" name="Picture 83" descr="A diagram of a group of people&#10;&#10;Description automatically generated">
            <a:extLst>
              <a:ext uri="{FF2B5EF4-FFF2-40B4-BE49-F238E27FC236}">
                <a16:creationId xmlns:a16="http://schemas.microsoft.com/office/drawing/2014/main" id="{786ADE7F-3AFA-6357-5387-C8AA43DCA9E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361"/>
          <a:stretch/>
        </p:blipFill>
        <p:spPr>
          <a:xfrm>
            <a:off x="452614" y="0"/>
            <a:ext cx="4500000" cy="2488758"/>
          </a:xfrm>
          <a:prstGeom prst="rect">
            <a:avLst/>
          </a:prstGeom>
        </p:spPr>
      </p:pic>
      <p:pic>
        <p:nvPicPr>
          <p:cNvPr id="86" name="Picture 85" descr="A white background with black lines and text&#10;&#10;Description automatically generated with medium confidence">
            <a:extLst>
              <a:ext uri="{FF2B5EF4-FFF2-40B4-BE49-F238E27FC236}">
                <a16:creationId xmlns:a16="http://schemas.microsoft.com/office/drawing/2014/main" id="{039BD728-4762-C5C3-B62A-837527A5849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388"/>
          <a:stretch/>
        </p:blipFill>
        <p:spPr>
          <a:xfrm>
            <a:off x="5214525" y="2844794"/>
            <a:ext cx="4500000" cy="2433701"/>
          </a:xfrm>
          <a:prstGeom prst="rect">
            <a:avLst/>
          </a:prstGeom>
        </p:spPr>
      </p:pic>
      <p:pic>
        <p:nvPicPr>
          <p:cNvPr id="88" name="Picture 87" descr="A diagram of a diagram&#10;&#10;Description automatically generated">
            <a:extLst>
              <a:ext uri="{FF2B5EF4-FFF2-40B4-BE49-F238E27FC236}">
                <a16:creationId xmlns:a16="http://schemas.microsoft.com/office/drawing/2014/main" id="{CCD64645-FDE6-80CF-23C3-B73DE7A1A63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b="20031"/>
          <a:stretch/>
        </p:blipFill>
        <p:spPr>
          <a:xfrm>
            <a:off x="452614" y="3423154"/>
            <a:ext cx="4500000" cy="1903049"/>
          </a:xfrm>
          <a:prstGeom prst="rect">
            <a:avLst/>
          </a:prstGeom>
        </p:spPr>
      </p:pic>
      <p:sp>
        <p:nvSpPr>
          <p:cNvPr id="91" name="TextBox 90">
            <a:extLst>
              <a:ext uri="{FF2B5EF4-FFF2-40B4-BE49-F238E27FC236}">
                <a16:creationId xmlns:a16="http://schemas.microsoft.com/office/drawing/2014/main" id="{C751E966-7DBE-AB40-A9EC-DC8799059463}"/>
              </a:ext>
            </a:extLst>
          </p:cNvPr>
          <p:cNvSpPr txBox="1"/>
          <p:nvPr/>
        </p:nvSpPr>
        <p:spPr>
          <a:xfrm>
            <a:off x="1323975" y="428625"/>
            <a:ext cx="19944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alaUV-NL1 SL RNA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2E232749-3099-C228-1469-9567B641398D}"/>
              </a:ext>
            </a:extLst>
          </p:cNvPr>
          <p:cNvSpPr txBox="1"/>
          <p:nvPr/>
        </p:nvSpPr>
        <p:spPr>
          <a:xfrm>
            <a:off x="1323975" y="3112262"/>
            <a:ext cx="20553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alaUV-NL1 SS RNA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D18F6D1F-D4BF-1C0C-79B3-65E94729EE14}"/>
              </a:ext>
            </a:extLst>
          </p:cNvPr>
          <p:cNvSpPr txBox="1"/>
          <p:nvPr/>
        </p:nvSpPr>
        <p:spPr>
          <a:xfrm>
            <a:off x="5442502" y="428625"/>
            <a:ext cx="3325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alaUV-NL1 SL RdRp poly protein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3FB0E078-1EA7-E37D-57C2-B0B70F712CDB}"/>
              </a:ext>
            </a:extLst>
          </p:cNvPr>
          <p:cNvSpPr txBox="1"/>
          <p:nvPr/>
        </p:nvSpPr>
        <p:spPr>
          <a:xfrm>
            <a:off x="6038850" y="3112262"/>
            <a:ext cx="28410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alaUV-NL1 Upp-SS1 protein</a:t>
            </a:r>
          </a:p>
        </p:txBody>
      </p: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70FAF834-BD2C-8A03-78BB-AE5EEBD12979}"/>
              </a:ext>
            </a:extLst>
          </p:cNvPr>
          <p:cNvGrpSpPr/>
          <p:nvPr/>
        </p:nvGrpSpPr>
        <p:grpSpPr>
          <a:xfrm>
            <a:off x="5264795" y="2303084"/>
            <a:ext cx="1477328" cy="280601"/>
            <a:chOff x="5297327" y="2394582"/>
            <a:chExt cx="1477328" cy="280601"/>
          </a:xfrm>
        </p:grpSpPr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623ACE6E-F9BD-86B5-8312-FBD6BB0AB833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6738655" y="2639183"/>
              <a:ext cx="72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C019E4EA-2343-6EFF-64E7-EA85FE6CF104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5265140" y="2639183"/>
              <a:ext cx="72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1" name="Group 100">
              <a:extLst>
                <a:ext uri="{FF2B5EF4-FFF2-40B4-BE49-F238E27FC236}">
                  <a16:creationId xmlns:a16="http://schemas.microsoft.com/office/drawing/2014/main" id="{1D6ADD7D-C42D-9821-3AF4-BC2EC219CCA3}"/>
                </a:ext>
              </a:extLst>
            </p:cNvPr>
            <p:cNvGrpSpPr/>
            <p:nvPr/>
          </p:nvGrpSpPr>
          <p:grpSpPr>
            <a:xfrm>
              <a:off x="5297327" y="2394582"/>
              <a:ext cx="1477328" cy="246221"/>
              <a:chOff x="5297327" y="2394582"/>
              <a:chExt cx="1477328" cy="246221"/>
            </a:xfrm>
          </p:grpSpPr>
          <p:cxnSp>
            <p:nvCxnSpPr>
              <p:cNvPr id="97" name="Straight Connector 96">
                <a:extLst>
                  <a:ext uri="{FF2B5EF4-FFF2-40B4-BE49-F238E27FC236}">
                    <a16:creationId xmlns:a16="http://schemas.microsoft.com/office/drawing/2014/main" id="{B9E8D0E5-85D9-A9D0-57C5-EC5E95BF4F0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297327" y="2639183"/>
                <a:ext cx="1477328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2E8EB905-61D5-BFF4-9D24-5F0455C32951}"/>
                  </a:ext>
                </a:extLst>
              </p:cNvPr>
              <p:cNvSpPr txBox="1"/>
              <p:nvPr/>
            </p:nvSpPr>
            <p:spPr>
              <a:xfrm>
                <a:off x="5796182" y="2394582"/>
                <a:ext cx="47961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/>
                  <a:t>0.220</a:t>
                </a:r>
              </a:p>
            </p:txBody>
          </p:sp>
        </p:grpSp>
      </p:grpSp>
      <p:grpSp>
        <p:nvGrpSpPr>
          <p:cNvPr id="104" name="Group 103">
            <a:extLst>
              <a:ext uri="{FF2B5EF4-FFF2-40B4-BE49-F238E27FC236}">
                <a16:creationId xmlns:a16="http://schemas.microsoft.com/office/drawing/2014/main" id="{EE6B0678-BB5E-F434-B8EA-0F0DDDAD4D1A}"/>
              </a:ext>
            </a:extLst>
          </p:cNvPr>
          <p:cNvGrpSpPr/>
          <p:nvPr/>
        </p:nvGrpSpPr>
        <p:grpSpPr>
          <a:xfrm>
            <a:off x="512765" y="2303084"/>
            <a:ext cx="1477328" cy="280601"/>
            <a:chOff x="5297327" y="2394582"/>
            <a:chExt cx="1477328" cy="280601"/>
          </a:xfrm>
        </p:grpSpPr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0F36EB7E-84E8-770D-D919-EAD31EB79984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6738655" y="2639183"/>
              <a:ext cx="72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08E7AFFA-530D-0347-5835-D5CAF49B775F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5265140" y="2639183"/>
              <a:ext cx="72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7" name="Group 106">
              <a:extLst>
                <a:ext uri="{FF2B5EF4-FFF2-40B4-BE49-F238E27FC236}">
                  <a16:creationId xmlns:a16="http://schemas.microsoft.com/office/drawing/2014/main" id="{945AE220-5AE8-DF57-E75B-83BC49D9B3B8}"/>
                </a:ext>
              </a:extLst>
            </p:cNvPr>
            <p:cNvGrpSpPr/>
            <p:nvPr/>
          </p:nvGrpSpPr>
          <p:grpSpPr>
            <a:xfrm>
              <a:off x="5297327" y="2394582"/>
              <a:ext cx="1477328" cy="246221"/>
              <a:chOff x="5297327" y="2394582"/>
              <a:chExt cx="1477328" cy="246221"/>
            </a:xfrm>
          </p:grpSpPr>
          <p:cxnSp>
            <p:nvCxnSpPr>
              <p:cNvPr id="108" name="Straight Connector 107">
                <a:extLst>
                  <a:ext uri="{FF2B5EF4-FFF2-40B4-BE49-F238E27FC236}">
                    <a16:creationId xmlns:a16="http://schemas.microsoft.com/office/drawing/2014/main" id="{6E85FD1B-2BB3-8969-43C7-9F6FDDFFCE9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297327" y="2639183"/>
                <a:ext cx="1477328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3B24990F-CDE9-C31D-DCAD-8DD340ADF338}"/>
                  </a:ext>
                </a:extLst>
              </p:cNvPr>
              <p:cNvSpPr txBox="1"/>
              <p:nvPr/>
            </p:nvSpPr>
            <p:spPr>
              <a:xfrm>
                <a:off x="5796181" y="2394582"/>
                <a:ext cx="47961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/>
                  <a:t>0.005</a:t>
                </a:r>
              </a:p>
            </p:txBody>
          </p:sp>
        </p:grpSp>
      </p:grpSp>
      <p:grpSp>
        <p:nvGrpSpPr>
          <p:cNvPr id="110" name="Group 109">
            <a:extLst>
              <a:ext uri="{FF2B5EF4-FFF2-40B4-BE49-F238E27FC236}">
                <a16:creationId xmlns:a16="http://schemas.microsoft.com/office/drawing/2014/main" id="{4ADF5756-9280-419B-A030-F524D37B5071}"/>
              </a:ext>
            </a:extLst>
          </p:cNvPr>
          <p:cNvGrpSpPr/>
          <p:nvPr/>
        </p:nvGrpSpPr>
        <p:grpSpPr>
          <a:xfrm>
            <a:off x="512765" y="5023907"/>
            <a:ext cx="1477328" cy="280601"/>
            <a:chOff x="5297327" y="2394582"/>
            <a:chExt cx="1477328" cy="280601"/>
          </a:xfrm>
        </p:grpSpPr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id="{7B4FF05C-A257-0EBE-DEDD-23E46B63FDC3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6738655" y="2639183"/>
              <a:ext cx="72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id="{27DA00B5-8BD9-06B2-3355-84B5681C4457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5265140" y="2639183"/>
              <a:ext cx="72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3" name="Group 112">
              <a:extLst>
                <a:ext uri="{FF2B5EF4-FFF2-40B4-BE49-F238E27FC236}">
                  <a16:creationId xmlns:a16="http://schemas.microsoft.com/office/drawing/2014/main" id="{74F5C0F6-2A5E-1615-C812-9959F76097B1}"/>
                </a:ext>
              </a:extLst>
            </p:cNvPr>
            <p:cNvGrpSpPr/>
            <p:nvPr/>
          </p:nvGrpSpPr>
          <p:grpSpPr>
            <a:xfrm>
              <a:off x="5297327" y="2394582"/>
              <a:ext cx="1477328" cy="246221"/>
              <a:chOff x="5297327" y="2394582"/>
              <a:chExt cx="1477328" cy="246221"/>
            </a:xfrm>
          </p:grpSpPr>
          <p:cxnSp>
            <p:nvCxnSpPr>
              <p:cNvPr id="114" name="Straight Connector 113">
                <a:extLst>
                  <a:ext uri="{FF2B5EF4-FFF2-40B4-BE49-F238E27FC236}">
                    <a16:creationId xmlns:a16="http://schemas.microsoft.com/office/drawing/2014/main" id="{15EA8F5F-8185-E2FA-7A4A-A6A657E7E88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297327" y="2639183"/>
                <a:ext cx="1477328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09416E75-CFDC-7C95-9270-D6F7AC6739B1}"/>
                  </a:ext>
                </a:extLst>
              </p:cNvPr>
              <p:cNvSpPr txBox="1"/>
              <p:nvPr/>
            </p:nvSpPr>
            <p:spPr>
              <a:xfrm>
                <a:off x="5796181" y="2394582"/>
                <a:ext cx="47961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/>
                  <a:t>0.009</a:t>
                </a:r>
              </a:p>
            </p:txBody>
          </p:sp>
        </p:grpSp>
      </p:grpSp>
      <p:grpSp>
        <p:nvGrpSpPr>
          <p:cNvPr id="116" name="Group 115">
            <a:extLst>
              <a:ext uri="{FF2B5EF4-FFF2-40B4-BE49-F238E27FC236}">
                <a16:creationId xmlns:a16="http://schemas.microsoft.com/office/drawing/2014/main" id="{F3E0C1A0-45B9-5DE8-DCD1-BEFA48E1E6AD}"/>
              </a:ext>
            </a:extLst>
          </p:cNvPr>
          <p:cNvGrpSpPr/>
          <p:nvPr/>
        </p:nvGrpSpPr>
        <p:grpSpPr>
          <a:xfrm>
            <a:off x="5276920" y="5023907"/>
            <a:ext cx="1512000" cy="280601"/>
            <a:chOff x="5297327" y="2394582"/>
            <a:chExt cx="1477328" cy="280601"/>
          </a:xfrm>
        </p:grpSpPr>
        <p:cxnSp>
          <p:nvCxnSpPr>
            <p:cNvPr id="117" name="Straight Connector 116">
              <a:extLst>
                <a:ext uri="{FF2B5EF4-FFF2-40B4-BE49-F238E27FC236}">
                  <a16:creationId xmlns:a16="http://schemas.microsoft.com/office/drawing/2014/main" id="{3386501B-89EF-FD4B-8111-1C2631E86A3D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6738655" y="2639183"/>
              <a:ext cx="72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Straight Connector 117">
              <a:extLst>
                <a:ext uri="{FF2B5EF4-FFF2-40B4-BE49-F238E27FC236}">
                  <a16:creationId xmlns:a16="http://schemas.microsoft.com/office/drawing/2014/main" id="{026DE363-48DD-9518-D0D2-E36D796089B7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5265140" y="2639183"/>
              <a:ext cx="72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9" name="Group 118">
              <a:extLst>
                <a:ext uri="{FF2B5EF4-FFF2-40B4-BE49-F238E27FC236}">
                  <a16:creationId xmlns:a16="http://schemas.microsoft.com/office/drawing/2014/main" id="{615FC306-24CC-5A7D-79AA-7004A0AFDF42}"/>
                </a:ext>
              </a:extLst>
            </p:cNvPr>
            <p:cNvGrpSpPr/>
            <p:nvPr/>
          </p:nvGrpSpPr>
          <p:grpSpPr>
            <a:xfrm>
              <a:off x="5297327" y="2394582"/>
              <a:ext cx="1477328" cy="246221"/>
              <a:chOff x="5297327" y="2394582"/>
              <a:chExt cx="1477328" cy="246221"/>
            </a:xfrm>
          </p:grpSpPr>
          <p:cxnSp>
            <p:nvCxnSpPr>
              <p:cNvPr id="120" name="Straight Connector 119">
                <a:extLst>
                  <a:ext uri="{FF2B5EF4-FFF2-40B4-BE49-F238E27FC236}">
                    <a16:creationId xmlns:a16="http://schemas.microsoft.com/office/drawing/2014/main" id="{558E0757-CAA6-DD9D-DCC7-EA542F837D4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297327" y="2639183"/>
                <a:ext cx="1477328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0352CD59-E262-8F12-DE72-C79BCF5B54B4}"/>
                  </a:ext>
                </a:extLst>
              </p:cNvPr>
              <p:cNvSpPr txBox="1"/>
              <p:nvPr/>
            </p:nvSpPr>
            <p:spPr>
              <a:xfrm>
                <a:off x="5801680" y="2394582"/>
                <a:ext cx="46862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/>
                  <a:t>0.015</a:t>
                </a:r>
              </a:p>
            </p:txBody>
          </p:sp>
        </p:grpSp>
      </p:grpSp>
      <p:sp>
        <p:nvSpPr>
          <p:cNvPr id="124" name="TextBox 123">
            <a:extLst>
              <a:ext uri="{FF2B5EF4-FFF2-40B4-BE49-F238E27FC236}">
                <a16:creationId xmlns:a16="http://schemas.microsoft.com/office/drawing/2014/main" id="{1C47059D-A588-A440-22BA-8078D015CEA8}"/>
              </a:ext>
            </a:extLst>
          </p:cNvPr>
          <p:cNvSpPr txBox="1"/>
          <p:nvPr/>
        </p:nvSpPr>
        <p:spPr>
          <a:xfrm>
            <a:off x="492982" y="5589917"/>
            <a:ext cx="8865704" cy="65185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wrap="square" rtlCol="0">
            <a:noAutofit/>
          </a:bodyPr>
          <a:lstStyle/>
          <a:p>
            <a:pPr algn="just">
              <a:tabLst>
                <a:tab pos="266700" algn="l"/>
              </a:tabLst>
            </a:pPr>
            <a:r>
              <a:rPr lang="en-US" sz="1200" b="1" dirty="0">
                <a:latin typeface="Aptos Narrow" panose="020B0004020202020204" pitchFamily="34" charset="0"/>
              </a:rPr>
              <a:t>Supplemental Figure SF1: Comparison of </a:t>
            </a:r>
            <a:r>
              <a:rPr lang="it-IT" sz="1200" b="1" dirty="0">
                <a:latin typeface="Aptos Narrow" panose="020B0004020202020204" pitchFamily="34" charset="0"/>
              </a:rPr>
              <a:t>Saccharina latissima unclassified virus 1 (SalaUV-NL1) variant sequences</a:t>
            </a:r>
            <a:endParaRPr lang="en-US" sz="1200" b="1" dirty="0">
              <a:latin typeface="Aptos Narrow" panose="020B0004020202020204" pitchFamily="34" charset="0"/>
            </a:endParaRPr>
          </a:p>
          <a:p>
            <a:pPr algn="just">
              <a:tabLst>
                <a:tab pos="266700" algn="l"/>
              </a:tabLst>
            </a:pPr>
            <a:r>
              <a:rPr lang="en-US" sz="1200" dirty="0">
                <a:latin typeface="Aptos Narrow" panose="020B0004020202020204" pitchFamily="34" charset="0"/>
              </a:rPr>
              <a:t>The Phylogenetic guide trees of the variant sequences were generated using the </a:t>
            </a:r>
            <a:r>
              <a:rPr lang="en-US" sz="1200" dirty="0" err="1">
                <a:latin typeface="Aptos Narrow" panose="020B0004020202020204" pitchFamily="34" charset="0"/>
              </a:rPr>
              <a:t>Clustal</a:t>
            </a:r>
            <a:r>
              <a:rPr lang="en-US" sz="1200" dirty="0">
                <a:latin typeface="Aptos Narrow" panose="020B0004020202020204" pitchFamily="34" charset="0"/>
              </a:rPr>
              <a:t> Omega 1.2.0 algorithm. The compared RNA or protein virus sequences are indicated above each tree. </a:t>
            </a:r>
          </a:p>
        </p:txBody>
      </p:sp>
    </p:spTree>
    <p:extLst>
      <p:ext uri="{BB962C8B-B14F-4D97-AF65-F5344CB8AC3E}">
        <p14:creationId xmlns:p14="http://schemas.microsoft.com/office/powerpoint/2010/main" val="3309928135"/>
      </p:ext>
    </p:extLst>
  </p:cSld>
  <p:clrMapOvr>
    <a:masterClrMapping/>
  </p:clrMapOvr>
</p:sld>
</file>

<file path=ppt/theme/theme1.xml><?xml version="1.0" encoding="utf-8"?>
<a:theme xmlns:a="http://schemas.openxmlformats.org/drawingml/2006/main" name="A4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A4" id="{FAD864B4-A2A7-48B6-B59C-6AC140E3F33F}" vid="{F4FA6F3F-62DE-454B-8B4D-2E2BE80B0868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0</TotalTime>
  <Words>64</Words>
  <Application>Microsoft Office PowerPoint</Application>
  <PresentationFormat>A4 Paper (210x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 Narrow</vt:lpstr>
      <vt:lpstr>Arial</vt:lpstr>
      <vt:lpstr>Calibri</vt:lpstr>
      <vt:lpstr>Calibri Light</vt:lpstr>
      <vt:lpstr>A4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imo Breit</dc:creator>
  <cp:lastModifiedBy>Timo Breit</cp:lastModifiedBy>
  <cp:revision>4</cp:revision>
  <dcterms:created xsi:type="dcterms:W3CDTF">2024-10-09T15:10:36Z</dcterms:created>
  <dcterms:modified xsi:type="dcterms:W3CDTF">2024-12-02T18:14:28Z</dcterms:modified>
</cp:coreProperties>
</file>